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5" r:id="rId2"/>
    <p:sldId id="262" r:id="rId3"/>
    <p:sldId id="25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97CA"/>
    <a:srgbClr val="218B22"/>
    <a:srgbClr val="FF9F9F"/>
    <a:srgbClr val="FFCCCC"/>
    <a:srgbClr val="7A5CC7"/>
    <a:srgbClr val="FFFFFF"/>
    <a:srgbClr val="8181F7"/>
    <a:srgbClr val="0D0DD9"/>
    <a:srgbClr val="66E0C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5406ACB-99D3-4F82-A313-34F7D396B26E}" v="5" dt="2025-09-01T00:42:13.79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927" autoAdjust="0"/>
    <p:restoredTop sz="87304" autoAdjust="0"/>
  </p:normalViewPr>
  <p:slideViewPr>
    <p:cSldViewPr snapToGrid="0">
      <p:cViewPr varScale="1">
        <p:scale>
          <a:sx n="58" d="100"/>
          <a:sy n="58" d="100"/>
        </p:scale>
        <p:origin x="2889" y="8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xy S" userId="a6b9145ce8d023a8" providerId="LiveId" clId="{DC699C2D-65BB-493E-8943-B79DCD841100}"/>
    <pc:docChg chg="custSel modSld">
      <pc:chgData name="xy S" userId="a6b9145ce8d023a8" providerId="LiveId" clId="{DC699C2D-65BB-493E-8943-B79DCD841100}" dt="2025-08-29T14:51:36.961" v="6" actId="1076"/>
      <pc:docMkLst>
        <pc:docMk/>
      </pc:docMkLst>
      <pc:sldChg chg="addSp delSp modSp mod">
        <pc:chgData name="xy S" userId="a6b9145ce8d023a8" providerId="LiveId" clId="{DC699C2D-65BB-493E-8943-B79DCD841100}" dt="2025-08-29T14:51:36.961" v="6" actId="1076"/>
        <pc:sldMkLst>
          <pc:docMk/>
          <pc:sldMk cId="325655714" sldId="257"/>
        </pc:sldMkLst>
      </pc:sldChg>
      <pc:sldChg chg="addSp delSp modSp mod">
        <pc:chgData name="xy S" userId="a6b9145ce8d023a8" providerId="LiveId" clId="{DC699C2D-65BB-493E-8943-B79DCD841100}" dt="2025-08-29T14:51:25.619" v="3" actId="1076"/>
        <pc:sldMkLst>
          <pc:docMk/>
          <pc:sldMk cId="1128688729" sldId="265"/>
        </pc:sldMkLst>
      </pc:sldChg>
    </pc:docChg>
  </pc:docChgLst>
  <pc:docChgLst>
    <pc:chgData name="xy S" userId="a6b9145ce8d023a8" providerId="LiveId" clId="{C5406ACB-99D3-4F82-A313-34F7D396B26E}"/>
    <pc:docChg chg="custSel modSld">
      <pc:chgData name="xy S" userId="a6b9145ce8d023a8" providerId="LiveId" clId="{C5406ACB-99D3-4F82-A313-34F7D396B26E}" dt="2025-09-01T00:42:23.932" v="56" actId="1076"/>
      <pc:docMkLst>
        <pc:docMk/>
      </pc:docMkLst>
      <pc:sldChg chg="addSp delSp modSp mod">
        <pc:chgData name="xy S" userId="a6b9145ce8d023a8" providerId="LiveId" clId="{C5406ACB-99D3-4F82-A313-34F7D396B26E}" dt="2025-09-01T00:42:23.932" v="56" actId="1076"/>
        <pc:sldMkLst>
          <pc:docMk/>
          <pc:sldMk cId="325655714" sldId="257"/>
        </pc:sldMkLst>
        <pc:spChg chg="mod">
          <ac:chgData name="xy S" userId="a6b9145ce8d023a8" providerId="LiveId" clId="{C5406ACB-99D3-4F82-A313-34F7D396B26E}" dt="2025-08-29T06:13:43.462" v="42" actId="2711"/>
          <ac:spMkLst>
            <pc:docMk/>
            <pc:sldMk cId="325655714" sldId="257"/>
            <ac:spMk id="16" creationId="{3C18194C-F9ED-FB5E-F146-1A14D9BE5490}"/>
          </ac:spMkLst>
        </pc:spChg>
        <pc:picChg chg="add del mod">
          <ac:chgData name="xy S" userId="a6b9145ce8d023a8" providerId="LiveId" clId="{C5406ACB-99D3-4F82-A313-34F7D396B26E}" dt="2025-09-01T00:42:21.579" v="55" actId="478"/>
          <ac:picMkLst>
            <pc:docMk/>
            <pc:sldMk cId="325655714" sldId="257"/>
            <ac:picMk id="3" creationId="{4E8DDFA8-2A2D-6AA9-3E36-A5EA5CF139DF}"/>
          </ac:picMkLst>
        </pc:picChg>
        <pc:picChg chg="add mod">
          <ac:chgData name="xy S" userId="a6b9145ce8d023a8" providerId="LiveId" clId="{C5406ACB-99D3-4F82-A313-34F7D396B26E}" dt="2025-09-01T00:42:23.932" v="56" actId="1076"/>
          <ac:picMkLst>
            <pc:docMk/>
            <pc:sldMk cId="325655714" sldId="257"/>
            <ac:picMk id="4" creationId="{4217DB79-F034-0E87-401E-63C0BD4D8573}"/>
          </ac:picMkLst>
        </pc:picChg>
      </pc:sldChg>
      <pc:sldChg chg="modSp mod">
        <pc:chgData name="xy S" userId="a6b9145ce8d023a8" providerId="LiveId" clId="{C5406ACB-99D3-4F82-A313-34F7D396B26E}" dt="2025-08-29T06:13:15.163" v="34" actId="2711"/>
        <pc:sldMkLst>
          <pc:docMk/>
          <pc:sldMk cId="2791015267" sldId="262"/>
        </pc:sldMkLst>
        <pc:spChg chg="mod">
          <ac:chgData name="xy S" userId="a6b9145ce8d023a8" providerId="LiveId" clId="{C5406ACB-99D3-4F82-A313-34F7D396B26E}" dt="2025-08-29T06:10:31.996" v="33" actId="20577"/>
          <ac:spMkLst>
            <pc:docMk/>
            <pc:sldMk cId="2791015267" sldId="262"/>
            <ac:spMk id="2" creationId="{9AA4AA23-B0DB-17AB-7D43-1E59784F734C}"/>
          </ac:spMkLst>
        </pc:spChg>
        <pc:spChg chg="mod">
          <ac:chgData name="xy S" userId="a6b9145ce8d023a8" providerId="LiveId" clId="{C5406ACB-99D3-4F82-A313-34F7D396B26E}" dt="2025-08-29T06:13:15.163" v="34" actId="2711"/>
          <ac:spMkLst>
            <pc:docMk/>
            <pc:sldMk cId="2791015267" sldId="262"/>
            <ac:spMk id="145" creationId="{D0420CFE-9BFC-49BF-7E5B-58E9718D8FF3}"/>
          </ac:spMkLst>
        </pc:spChg>
        <pc:spChg chg="mod">
          <ac:chgData name="xy S" userId="a6b9145ce8d023a8" providerId="LiveId" clId="{C5406ACB-99D3-4F82-A313-34F7D396B26E}" dt="2025-08-29T06:13:15.163" v="34" actId="2711"/>
          <ac:spMkLst>
            <pc:docMk/>
            <pc:sldMk cId="2791015267" sldId="262"/>
            <ac:spMk id="146" creationId="{86051862-39A2-1A48-E974-767437E66FFE}"/>
          </ac:spMkLst>
        </pc:spChg>
        <pc:spChg chg="mod">
          <ac:chgData name="xy S" userId="a6b9145ce8d023a8" providerId="LiveId" clId="{C5406ACB-99D3-4F82-A313-34F7D396B26E}" dt="2025-08-29T06:13:15.163" v="34" actId="2711"/>
          <ac:spMkLst>
            <pc:docMk/>
            <pc:sldMk cId="2791015267" sldId="262"/>
            <ac:spMk id="147" creationId="{DA716BF4-D494-4769-98C8-C4A98B9FB290}"/>
          </ac:spMkLst>
        </pc:spChg>
        <pc:spChg chg="mod">
          <ac:chgData name="xy S" userId="a6b9145ce8d023a8" providerId="LiveId" clId="{C5406ACB-99D3-4F82-A313-34F7D396B26E}" dt="2025-08-29T06:13:15.163" v="34" actId="2711"/>
          <ac:spMkLst>
            <pc:docMk/>
            <pc:sldMk cId="2791015267" sldId="262"/>
            <ac:spMk id="148" creationId="{E07CA87C-E56A-4BFC-3228-1EA46DA5F511}"/>
          </ac:spMkLst>
        </pc:spChg>
        <pc:spChg chg="mod">
          <ac:chgData name="xy S" userId="a6b9145ce8d023a8" providerId="LiveId" clId="{C5406ACB-99D3-4F82-A313-34F7D396B26E}" dt="2025-08-29T06:13:15.163" v="34" actId="2711"/>
          <ac:spMkLst>
            <pc:docMk/>
            <pc:sldMk cId="2791015267" sldId="262"/>
            <ac:spMk id="153" creationId="{28920B08-433E-E75C-140F-3E8E970C9C13}"/>
          </ac:spMkLst>
        </pc:spChg>
        <pc:spChg chg="mod">
          <ac:chgData name="xy S" userId="a6b9145ce8d023a8" providerId="LiveId" clId="{C5406ACB-99D3-4F82-A313-34F7D396B26E}" dt="2025-08-29T06:13:15.163" v="34" actId="2711"/>
          <ac:spMkLst>
            <pc:docMk/>
            <pc:sldMk cId="2791015267" sldId="262"/>
            <ac:spMk id="156" creationId="{EFB86C4E-4872-700B-9B16-1BBA5FB2F097}"/>
          </ac:spMkLst>
        </pc:spChg>
        <pc:spChg chg="mod">
          <ac:chgData name="xy S" userId="a6b9145ce8d023a8" providerId="LiveId" clId="{C5406ACB-99D3-4F82-A313-34F7D396B26E}" dt="2025-08-29T06:13:15.163" v="34" actId="2711"/>
          <ac:spMkLst>
            <pc:docMk/>
            <pc:sldMk cId="2791015267" sldId="262"/>
            <ac:spMk id="164" creationId="{5FE752CF-DDBD-28CA-D7E5-8829C061F0D4}"/>
          </ac:spMkLst>
        </pc:spChg>
        <pc:spChg chg="mod">
          <ac:chgData name="xy S" userId="a6b9145ce8d023a8" providerId="LiveId" clId="{C5406ACB-99D3-4F82-A313-34F7D396B26E}" dt="2025-08-29T06:13:15.163" v="34" actId="2711"/>
          <ac:spMkLst>
            <pc:docMk/>
            <pc:sldMk cId="2791015267" sldId="262"/>
            <ac:spMk id="172" creationId="{14073877-7538-4E7E-C3CD-275FFE503A43}"/>
          </ac:spMkLst>
        </pc:spChg>
        <pc:spChg chg="mod">
          <ac:chgData name="xy S" userId="a6b9145ce8d023a8" providerId="LiveId" clId="{C5406ACB-99D3-4F82-A313-34F7D396B26E}" dt="2025-08-29T06:13:15.163" v="34" actId="2711"/>
          <ac:spMkLst>
            <pc:docMk/>
            <pc:sldMk cId="2791015267" sldId="262"/>
            <ac:spMk id="174" creationId="{E23148B4-8C0C-FDA0-6C1B-67C53F162DAD}"/>
          </ac:spMkLst>
        </pc:spChg>
        <pc:spChg chg="mod">
          <ac:chgData name="xy S" userId="a6b9145ce8d023a8" providerId="LiveId" clId="{C5406ACB-99D3-4F82-A313-34F7D396B26E}" dt="2025-08-29T06:13:15.163" v="34" actId="2711"/>
          <ac:spMkLst>
            <pc:docMk/>
            <pc:sldMk cId="2791015267" sldId="262"/>
            <ac:spMk id="184" creationId="{6CD67694-72E7-90C6-8DA7-7CC6FEF413D9}"/>
          </ac:spMkLst>
        </pc:spChg>
      </pc:sldChg>
      <pc:sldChg chg="addSp delSp modSp mod">
        <pc:chgData name="xy S" userId="a6b9145ce8d023a8" providerId="LiveId" clId="{C5406ACB-99D3-4F82-A313-34F7D396B26E}" dt="2025-09-01T00:42:04.671" v="50" actId="1076"/>
        <pc:sldMkLst>
          <pc:docMk/>
          <pc:sldMk cId="1128688729" sldId="265"/>
        </pc:sldMkLst>
        <pc:spChg chg="mod">
          <ac:chgData name="xy S" userId="a6b9145ce8d023a8" providerId="LiveId" clId="{C5406ACB-99D3-4F82-A313-34F7D396B26E}" dt="2025-08-29T06:13:24.254" v="35" actId="2711"/>
          <ac:spMkLst>
            <pc:docMk/>
            <pc:sldMk cId="1128688729" sldId="265"/>
            <ac:spMk id="4" creationId="{1967E92C-B3AC-4B85-B49E-5AF5C3F4817C}"/>
          </ac:spMkLst>
        </pc:spChg>
        <pc:picChg chg="add mod">
          <ac:chgData name="xy S" userId="a6b9145ce8d023a8" providerId="LiveId" clId="{C5406ACB-99D3-4F82-A313-34F7D396B26E}" dt="2025-09-01T00:42:04.671" v="50" actId="1076"/>
          <ac:picMkLst>
            <pc:docMk/>
            <pc:sldMk cId="1128688729" sldId="265"/>
            <ac:picMk id="3" creationId="{C08C0002-D9CC-133D-86D3-634E3700CEC0}"/>
          </ac:picMkLst>
        </pc:picChg>
        <pc:picChg chg="del">
          <ac:chgData name="xy S" userId="a6b9145ce8d023a8" providerId="LiveId" clId="{C5406ACB-99D3-4F82-A313-34F7D396B26E}" dt="2025-09-01T00:41:55.304" v="48" actId="478"/>
          <ac:picMkLst>
            <pc:docMk/>
            <pc:sldMk cId="1128688729" sldId="265"/>
            <ac:picMk id="5" creationId="{707558EA-3892-48BB-A46C-CEAA52930BC6}"/>
          </ac:picMkLst>
        </pc:picChg>
      </pc:sldChg>
    </pc:docChg>
  </pc:docChgLst>
  <pc:docChgLst>
    <pc:chgData name="xy S" userId="a6b9145ce8d023a8" providerId="LiveId" clId="{B7265B5A-FC9B-47A4-9A70-9584022FCD3B}"/>
    <pc:docChg chg="modSld">
      <pc:chgData name="xy S" userId="a6b9145ce8d023a8" providerId="LiveId" clId="{B7265B5A-FC9B-47A4-9A70-9584022FCD3B}" dt="2025-08-02T15:45:38.391" v="62" actId="20577"/>
      <pc:docMkLst>
        <pc:docMk/>
      </pc:docMkLst>
      <pc:sldChg chg="modSp mod">
        <pc:chgData name="xy S" userId="a6b9145ce8d023a8" providerId="LiveId" clId="{B7265B5A-FC9B-47A4-9A70-9584022FCD3B}" dt="2025-08-02T15:45:38.391" v="62" actId="20577"/>
        <pc:sldMkLst>
          <pc:docMk/>
          <pc:sldMk cId="325655714" sldId="257"/>
        </pc:sldMkLst>
        <pc:spChg chg="mod">
          <ac:chgData name="xy S" userId="a6b9145ce8d023a8" providerId="LiveId" clId="{B7265B5A-FC9B-47A4-9A70-9584022FCD3B}" dt="2025-08-02T15:45:38.391" v="62" actId="20577"/>
          <ac:spMkLst>
            <pc:docMk/>
            <pc:sldMk cId="325655714" sldId="257"/>
            <ac:spMk id="16" creationId="{3C18194C-F9ED-FB5E-F146-1A14D9BE5490}"/>
          </ac:spMkLst>
        </pc:spChg>
      </pc:sldChg>
      <pc:sldChg chg="modSp mod">
        <pc:chgData name="xy S" userId="a6b9145ce8d023a8" providerId="LiveId" clId="{B7265B5A-FC9B-47A4-9A70-9584022FCD3B}" dt="2025-08-02T15:43:25.906" v="13"/>
        <pc:sldMkLst>
          <pc:docMk/>
          <pc:sldMk cId="2791015267" sldId="262"/>
        </pc:sldMkLst>
        <pc:spChg chg="mod">
          <ac:chgData name="xy S" userId="a6b9145ce8d023a8" providerId="LiveId" clId="{B7265B5A-FC9B-47A4-9A70-9584022FCD3B}" dt="2025-08-02T15:43:25.906" v="13"/>
          <ac:spMkLst>
            <pc:docMk/>
            <pc:sldMk cId="2791015267" sldId="262"/>
            <ac:spMk id="2" creationId="{9AA4AA23-B0DB-17AB-7D43-1E59784F734C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4739AB-A24F-4631-81A5-66C3C4B20430}" type="datetimeFigureOut">
              <a:rPr lang="zh-CN" altLang="en-US" smtClean="0"/>
              <a:t>2025/9/1 Mon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596E0-3421-4CC2-BE7A-EDFAC7E391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6758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4BEEDC8-12F0-49B3-AF07-E50AA19931E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21681184-F5A5-90D2-F7B6-747354E1E05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93999125-A483-88A5-030C-858A689E649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809CF4-CE90-B5EF-00E4-4C970920517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4596E0-3421-4CC2-BE7A-EDFAC7E39136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06158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4596E0-3421-4CC2-BE7A-EDFAC7E39136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88867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4596E0-3421-4CC2-BE7A-EDFAC7E39136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92635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CN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C2350-CDD6-4D8E-B76F-7A4B8BDEC287}" type="datetimeFigureOut">
              <a:rPr lang="zh-CN" altLang="en-US" smtClean="0"/>
              <a:t>2025/9/1 Mon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981CC-CA5F-4D4A-AA76-DAEEEC755E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06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C2350-CDD6-4D8E-B76F-7A4B8BDEC287}" type="datetimeFigureOut">
              <a:rPr lang="zh-CN" altLang="en-US" smtClean="0"/>
              <a:t>2025/9/1 Mon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981CC-CA5F-4D4A-AA76-DAEEEC755E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717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C2350-CDD6-4D8E-B76F-7A4B8BDEC287}" type="datetimeFigureOut">
              <a:rPr lang="zh-CN" altLang="en-US" smtClean="0"/>
              <a:t>2025/9/1 Mon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981CC-CA5F-4D4A-AA76-DAEEEC755E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1564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C2350-CDD6-4D8E-B76F-7A4B8BDEC287}" type="datetimeFigureOut">
              <a:rPr lang="zh-CN" altLang="en-US" smtClean="0"/>
              <a:t>2025/9/1 Mon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981CC-CA5F-4D4A-AA76-DAEEEC755E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8304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C2350-CDD6-4D8E-B76F-7A4B8BDEC287}" type="datetimeFigureOut">
              <a:rPr lang="zh-CN" altLang="en-US" smtClean="0"/>
              <a:t>2025/9/1 Mon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981CC-CA5F-4D4A-AA76-DAEEEC755E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3196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C2350-CDD6-4D8E-B76F-7A4B8BDEC287}" type="datetimeFigureOut">
              <a:rPr lang="zh-CN" altLang="en-US" smtClean="0"/>
              <a:t>2025/9/1 Mon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981CC-CA5F-4D4A-AA76-DAEEEC755E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3909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C2350-CDD6-4D8E-B76F-7A4B8BDEC287}" type="datetimeFigureOut">
              <a:rPr lang="zh-CN" altLang="en-US" smtClean="0"/>
              <a:t>2025/9/1 Mon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981CC-CA5F-4D4A-AA76-DAEEEC755E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8847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C2350-CDD6-4D8E-B76F-7A4B8BDEC287}" type="datetimeFigureOut">
              <a:rPr lang="zh-CN" altLang="en-US" smtClean="0"/>
              <a:t>2025/9/1 Mon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981CC-CA5F-4D4A-AA76-DAEEEC755E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30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C2350-CDD6-4D8E-B76F-7A4B8BDEC287}" type="datetimeFigureOut">
              <a:rPr lang="zh-CN" altLang="en-US" smtClean="0"/>
              <a:t>2025/9/1 Mon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981CC-CA5F-4D4A-AA76-DAEEEC755E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9102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C2350-CDD6-4D8E-B76F-7A4B8BDEC287}" type="datetimeFigureOut">
              <a:rPr lang="zh-CN" altLang="en-US" smtClean="0"/>
              <a:t>2025/9/1 Mon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981CC-CA5F-4D4A-AA76-DAEEEC755E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1138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CN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C2350-CDD6-4D8E-B76F-7A4B8BDEC287}" type="datetimeFigureOut">
              <a:rPr lang="zh-CN" altLang="en-US" smtClean="0"/>
              <a:t>2025/9/1 Mon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981CC-CA5F-4D4A-AA76-DAEEEC755E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69695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C2350-CDD6-4D8E-B76F-7A4B8BDEC287}" type="datetimeFigureOut">
              <a:rPr lang="zh-CN" altLang="en-US" smtClean="0"/>
              <a:t>2025/9/1 Mon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981CC-CA5F-4D4A-AA76-DAEEEC755E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18952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B81BF1D-E443-B3A3-2A0F-C29CDA2B453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5">
            <a:extLst>
              <a:ext uri="{FF2B5EF4-FFF2-40B4-BE49-F238E27FC236}">
                <a16:creationId xmlns:a16="http://schemas.microsoft.com/office/drawing/2014/main" id="{1967E92C-B3AC-4B85-B49E-5AF5C3F4817C}"/>
              </a:ext>
            </a:extLst>
          </p:cNvPr>
          <p:cNvSpPr txBox="1"/>
          <p:nvPr/>
        </p:nvSpPr>
        <p:spPr>
          <a:xfrm>
            <a:off x="509380" y="2784488"/>
            <a:ext cx="5839241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zh-CN" sz="1100" kern="100" dirty="0">
                <a:effectLst/>
                <a:latin typeface="Times New Roman" panose="02020603050405020304" pitchFamily="18" charset="0"/>
                <a:ea typeface="新宋体" panose="02010609030101010101" pitchFamily="49" charset="-122"/>
                <a:cs typeface="Times New Roman" panose="02020603050405020304" pitchFamily="18" charset="0"/>
              </a:rPr>
              <a:t>Supplemental Figure </a:t>
            </a:r>
            <a:r>
              <a:rPr lang="en-US" altLang="zh-CN" sz="1100" kern="100" dirty="0">
                <a:latin typeface="Times New Roman" panose="02020603050405020304" pitchFamily="18" charset="0"/>
                <a:ea typeface="新宋体" panose="02010609030101010101" pitchFamily="49" charset="-122"/>
                <a:cs typeface="Times New Roman" panose="02020603050405020304" pitchFamily="18" charset="0"/>
              </a:rPr>
              <a:t>1</a:t>
            </a:r>
            <a:r>
              <a:rPr lang="en-US" altLang="zh-CN" sz="1100" kern="100" dirty="0">
                <a:effectLst/>
                <a:latin typeface="Times New Roman" panose="02020603050405020304" pitchFamily="18" charset="0"/>
                <a:ea typeface="新宋体" panose="02010609030101010101" pitchFamily="49" charset="-122"/>
                <a:cs typeface="Times New Roman" panose="02020603050405020304" pitchFamily="18" charset="0"/>
              </a:rPr>
              <a:t>. Southern blot results of GM06891 (118), NA06968 (32</a:t>
            </a:r>
            <a:r>
              <a:rPr lang="en-US" altLang="zh-CN" sz="1100" kern="100" dirty="0">
                <a:latin typeface="Times New Roman" panose="02020603050405020304" pitchFamily="18" charset="0"/>
                <a:ea typeface="新宋体" panose="02010609030101010101" pitchFamily="49" charset="-122"/>
                <a:cs typeface="Times New Roman" panose="02020603050405020304" pitchFamily="18" charset="0"/>
              </a:rPr>
              <a:t>,</a:t>
            </a:r>
            <a:r>
              <a:rPr lang="zh-CN" altLang="en-US" sz="1100" kern="100" dirty="0">
                <a:latin typeface="Times New Roman" panose="02020603050405020304" pitchFamily="18" charset="0"/>
                <a:ea typeface="新宋体" panose="02010609030101010101" pitchFamily="49" charset="-122"/>
                <a:cs typeface="Times New Roman" panose="02020603050405020304" pitchFamily="18" charset="0"/>
              </a:rPr>
              <a:t> </a:t>
            </a:r>
            <a:r>
              <a:rPr lang="en-US" altLang="zh-CN" sz="1100" kern="100" dirty="0">
                <a:latin typeface="Times New Roman" panose="02020603050405020304" pitchFamily="18" charset="0"/>
                <a:ea typeface="新宋体" panose="02010609030101010101" pitchFamily="49" charset="-122"/>
                <a:cs typeface="Times New Roman" panose="02020603050405020304" pitchFamily="18" charset="0"/>
              </a:rPr>
              <a:t>107</a:t>
            </a:r>
            <a:r>
              <a:rPr lang="en-US" altLang="zh-CN" sz="1100" kern="100" dirty="0">
                <a:effectLst/>
                <a:latin typeface="Times New Roman" panose="02020603050405020304" pitchFamily="18" charset="0"/>
                <a:ea typeface="新宋体" panose="02010609030101010101" pitchFamily="49" charset="-122"/>
                <a:cs typeface="Times New Roman" panose="02020603050405020304" pitchFamily="18" charset="0"/>
              </a:rPr>
              <a:t>), NA04025 (&gt; 200) and GM07537 (28 – 29, &gt; 200).  </a:t>
            </a:r>
            <a:endParaRPr lang="zh-CN" altLang="zh-CN" sz="11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08C0002-D9CC-133D-86D3-634E3700CEC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8026" y="432610"/>
            <a:ext cx="1210056" cy="19232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86887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5" name="Picture 194">
            <a:extLst>
              <a:ext uri="{FF2B5EF4-FFF2-40B4-BE49-F238E27FC236}">
                <a16:creationId xmlns:a16="http://schemas.microsoft.com/office/drawing/2014/main" id="{34B57735-8324-9FA3-51D6-3591A86F76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6055" y="2906178"/>
            <a:ext cx="5518931" cy="1911848"/>
          </a:xfrm>
          <a:prstGeom prst="rect">
            <a:avLst/>
          </a:prstGeom>
        </p:spPr>
      </p:pic>
      <p:pic>
        <p:nvPicPr>
          <p:cNvPr id="193" name="Picture 192">
            <a:extLst>
              <a:ext uri="{FF2B5EF4-FFF2-40B4-BE49-F238E27FC236}">
                <a16:creationId xmlns:a16="http://schemas.microsoft.com/office/drawing/2014/main" id="{7853C4C6-750E-600B-17B1-07F4E96F87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7312" y="631782"/>
            <a:ext cx="5518931" cy="1911848"/>
          </a:xfrm>
          <a:prstGeom prst="rect">
            <a:avLst/>
          </a:prstGeom>
        </p:spPr>
      </p:pic>
      <p:sp>
        <p:nvSpPr>
          <p:cNvPr id="146" name="文本框 40">
            <a:extLst>
              <a:ext uri="{FF2B5EF4-FFF2-40B4-BE49-F238E27FC236}">
                <a16:creationId xmlns:a16="http://schemas.microsoft.com/office/drawing/2014/main" id="{86051862-39A2-1A48-E974-767437E66FFE}"/>
              </a:ext>
            </a:extLst>
          </p:cNvPr>
          <p:cNvSpPr txBox="1"/>
          <p:nvPr/>
        </p:nvSpPr>
        <p:spPr>
          <a:xfrm>
            <a:off x="227907" y="2823667"/>
            <a:ext cx="411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7" name="Group 186">
            <a:extLst>
              <a:ext uri="{FF2B5EF4-FFF2-40B4-BE49-F238E27FC236}">
                <a16:creationId xmlns:a16="http://schemas.microsoft.com/office/drawing/2014/main" id="{C9EC127D-CFCE-F9E9-C22E-97AEDBD82D31}"/>
              </a:ext>
            </a:extLst>
          </p:cNvPr>
          <p:cNvGrpSpPr/>
          <p:nvPr/>
        </p:nvGrpSpPr>
        <p:grpSpPr>
          <a:xfrm>
            <a:off x="5531521" y="3131444"/>
            <a:ext cx="1326479" cy="1461313"/>
            <a:chOff x="5623543" y="3216959"/>
            <a:chExt cx="1326479" cy="1461313"/>
          </a:xfrm>
        </p:grpSpPr>
        <p:sp>
          <p:nvSpPr>
            <p:cNvPr id="163" name="橢圓 17">
              <a:extLst>
                <a:ext uri="{FF2B5EF4-FFF2-40B4-BE49-F238E27FC236}">
                  <a16:creationId xmlns:a16="http://schemas.microsoft.com/office/drawing/2014/main" id="{89AAF97B-CC2B-BF19-CCA2-B749032A6548}"/>
                </a:ext>
              </a:extLst>
            </p:cNvPr>
            <p:cNvSpPr/>
            <p:nvPr/>
          </p:nvSpPr>
          <p:spPr>
            <a:xfrm>
              <a:off x="5623543" y="3246292"/>
              <a:ext cx="126000" cy="126000"/>
            </a:xfrm>
            <a:prstGeom prst="ellipse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zh-TW" altLang="en-US" sz="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文字方塊 19">
              <a:extLst>
                <a:ext uri="{FF2B5EF4-FFF2-40B4-BE49-F238E27FC236}">
                  <a16:creationId xmlns:a16="http://schemas.microsoft.com/office/drawing/2014/main" id="{B35392A0-40BC-B4B2-8A9A-EDFB0CC9CA60}"/>
                </a:ext>
              </a:extLst>
            </p:cNvPr>
            <p:cNvSpPr txBox="1"/>
            <p:nvPr/>
          </p:nvSpPr>
          <p:spPr>
            <a:xfrm>
              <a:off x="5762133" y="3216959"/>
              <a:ext cx="11878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/IM female</a:t>
              </a:r>
              <a:endParaRPr lang="zh-TW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矩形 18">
              <a:extLst>
                <a:ext uri="{FF2B5EF4-FFF2-40B4-BE49-F238E27FC236}">
                  <a16:creationId xmlns:a16="http://schemas.microsoft.com/office/drawing/2014/main" id="{5FE752CF-DDBD-28CA-D7E5-8829C061F0D4}"/>
                </a:ext>
              </a:extLst>
            </p:cNvPr>
            <p:cNvSpPr/>
            <p:nvPr/>
          </p:nvSpPr>
          <p:spPr>
            <a:xfrm>
              <a:off x="5623543" y="3459067"/>
              <a:ext cx="126000" cy="126000"/>
            </a:xfrm>
            <a:prstGeom prst="rect">
              <a:avLst/>
            </a:prstGeom>
            <a:noFill/>
            <a:ln w="952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zh-TW" altLang="en-US" sz="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文字方塊 19">
              <a:extLst>
                <a:ext uri="{FF2B5EF4-FFF2-40B4-BE49-F238E27FC236}">
                  <a16:creationId xmlns:a16="http://schemas.microsoft.com/office/drawing/2014/main" id="{EF5BAF2C-F70D-9D46-8D19-3C1A687A572E}"/>
                </a:ext>
              </a:extLst>
            </p:cNvPr>
            <p:cNvSpPr txBox="1"/>
            <p:nvPr/>
          </p:nvSpPr>
          <p:spPr>
            <a:xfrm>
              <a:off x="5762133" y="3429734"/>
              <a:ext cx="11878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</a:t>
              </a:r>
              <a:r>
                <a:rPr lang="en-US" altLang="zh-TW" sz="600">
                  <a:latin typeface="Times New Roman" panose="02020603050405020304" pitchFamily="18" charset="0"/>
                  <a:cs typeface="Times New Roman" panose="02020603050405020304" pitchFamily="18" charset="0"/>
                </a:rPr>
                <a:t>/IM </a:t>
              </a:r>
              <a:r>
                <a:rPr lang="en-US" altLang="zh-TW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e</a:t>
              </a:r>
              <a:endParaRPr lang="zh-TW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70" name="Group 169">
              <a:extLst>
                <a:ext uri="{FF2B5EF4-FFF2-40B4-BE49-F238E27FC236}">
                  <a16:creationId xmlns:a16="http://schemas.microsoft.com/office/drawing/2014/main" id="{8A46054C-ED54-9365-71B6-2EC9DCF20DA1}"/>
                </a:ext>
              </a:extLst>
            </p:cNvPr>
            <p:cNvGrpSpPr/>
            <p:nvPr/>
          </p:nvGrpSpPr>
          <p:grpSpPr>
            <a:xfrm>
              <a:off x="5623543" y="3671842"/>
              <a:ext cx="126000" cy="126000"/>
              <a:chOff x="4682342" y="5009171"/>
              <a:chExt cx="288000" cy="288000"/>
            </a:xfrm>
          </p:grpSpPr>
          <p:sp>
            <p:nvSpPr>
              <p:cNvPr id="152" name="橢圓 6">
                <a:extLst>
                  <a:ext uri="{FF2B5EF4-FFF2-40B4-BE49-F238E27FC236}">
                    <a16:creationId xmlns:a16="http://schemas.microsoft.com/office/drawing/2014/main" id="{C8FEABF1-B435-BAEA-C7D8-8C3FB7C5B03A}"/>
                  </a:ext>
                </a:extLst>
              </p:cNvPr>
              <p:cNvSpPr/>
              <p:nvPr/>
            </p:nvSpPr>
            <p:spPr>
              <a:xfrm>
                <a:off x="4682342" y="5009171"/>
                <a:ext cx="288000" cy="288000"/>
              </a:xfrm>
              <a:prstGeom prst="ellipse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" name="橢圓 7">
                <a:extLst>
                  <a:ext uri="{FF2B5EF4-FFF2-40B4-BE49-F238E27FC236}">
                    <a16:creationId xmlns:a16="http://schemas.microsoft.com/office/drawing/2014/main" id="{28920B08-433E-E75C-140F-3E8E970C9C13}"/>
                  </a:ext>
                </a:extLst>
              </p:cNvPr>
              <p:cNvSpPr/>
              <p:nvPr/>
            </p:nvSpPr>
            <p:spPr>
              <a:xfrm>
                <a:off x="4754342" y="5081171"/>
                <a:ext cx="144000" cy="144000"/>
              </a:xfrm>
              <a:prstGeom prst="ellipse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72" name="文字方塊 19">
              <a:extLst>
                <a:ext uri="{FF2B5EF4-FFF2-40B4-BE49-F238E27FC236}">
                  <a16:creationId xmlns:a16="http://schemas.microsoft.com/office/drawing/2014/main" id="{14073877-7538-4E7E-C3CD-275FFE503A43}"/>
                </a:ext>
              </a:extLst>
            </p:cNvPr>
            <p:cNvSpPr txBox="1"/>
            <p:nvPr/>
          </p:nvSpPr>
          <p:spPr>
            <a:xfrm>
              <a:off x="5762133" y="3642509"/>
              <a:ext cx="11878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M female</a:t>
              </a:r>
              <a:endParaRPr lang="zh-TW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54" name="群組 8">
              <a:extLst>
                <a:ext uri="{FF2B5EF4-FFF2-40B4-BE49-F238E27FC236}">
                  <a16:creationId xmlns:a16="http://schemas.microsoft.com/office/drawing/2014/main" id="{1CACAE73-19BE-778F-D0C5-39A7CF52732B}"/>
                </a:ext>
              </a:extLst>
            </p:cNvPr>
            <p:cNvGrpSpPr/>
            <p:nvPr/>
          </p:nvGrpSpPr>
          <p:grpSpPr>
            <a:xfrm>
              <a:off x="5623543" y="3884617"/>
              <a:ext cx="126000" cy="126000"/>
              <a:chOff x="9094176" y="5339059"/>
              <a:chExt cx="360000" cy="360000"/>
            </a:xfrm>
          </p:grpSpPr>
          <p:sp>
            <p:nvSpPr>
              <p:cNvPr id="155" name="矩形 9">
                <a:extLst>
                  <a:ext uri="{FF2B5EF4-FFF2-40B4-BE49-F238E27FC236}">
                    <a16:creationId xmlns:a16="http://schemas.microsoft.com/office/drawing/2014/main" id="{22B81182-4878-19EB-672B-F041E7236464}"/>
                  </a:ext>
                </a:extLst>
              </p:cNvPr>
              <p:cNvSpPr/>
              <p:nvPr/>
            </p:nvSpPr>
            <p:spPr>
              <a:xfrm>
                <a:off x="9094176" y="5339059"/>
                <a:ext cx="360000" cy="360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6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" name="矩形 10">
                <a:extLst>
                  <a:ext uri="{FF2B5EF4-FFF2-40B4-BE49-F238E27FC236}">
                    <a16:creationId xmlns:a16="http://schemas.microsoft.com/office/drawing/2014/main" id="{EFB86C4E-4872-700B-9B16-1BBA5FB2F097}"/>
                  </a:ext>
                </a:extLst>
              </p:cNvPr>
              <p:cNvSpPr/>
              <p:nvPr/>
            </p:nvSpPr>
            <p:spPr>
              <a:xfrm>
                <a:off x="9184176" y="5429059"/>
                <a:ext cx="180000" cy="180000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6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74" name="文字方塊 19">
              <a:extLst>
                <a:ext uri="{FF2B5EF4-FFF2-40B4-BE49-F238E27FC236}">
                  <a16:creationId xmlns:a16="http://schemas.microsoft.com/office/drawing/2014/main" id="{E23148B4-8C0C-FDA0-6C1B-67C53F162DAD}"/>
                </a:ext>
              </a:extLst>
            </p:cNvPr>
            <p:cNvSpPr txBox="1"/>
            <p:nvPr/>
          </p:nvSpPr>
          <p:spPr>
            <a:xfrm>
              <a:off x="5762133" y="3855284"/>
              <a:ext cx="11878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M male</a:t>
              </a:r>
              <a:endParaRPr lang="zh-TW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矩形 2">
              <a:extLst>
                <a:ext uri="{FF2B5EF4-FFF2-40B4-BE49-F238E27FC236}">
                  <a16:creationId xmlns:a16="http://schemas.microsoft.com/office/drawing/2014/main" id="{E07CA87C-E56A-4BFC-3228-1EA46DA5F511}"/>
                </a:ext>
              </a:extLst>
            </p:cNvPr>
            <p:cNvSpPr/>
            <p:nvPr/>
          </p:nvSpPr>
          <p:spPr>
            <a:xfrm>
              <a:off x="5623543" y="4310167"/>
              <a:ext cx="126000" cy="126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文字方塊 19">
              <a:extLst>
                <a:ext uri="{FF2B5EF4-FFF2-40B4-BE49-F238E27FC236}">
                  <a16:creationId xmlns:a16="http://schemas.microsoft.com/office/drawing/2014/main" id="{AE402E2E-ED4B-0F0D-B045-DC609C8DF032}"/>
                </a:ext>
              </a:extLst>
            </p:cNvPr>
            <p:cNvSpPr txBox="1"/>
            <p:nvPr/>
          </p:nvSpPr>
          <p:spPr>
            <a:xfrm>
              <a:off x="5762133" y="4280834"/>
              <a:ext cx="11878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M male</a:t>
              </a:r>
              <a:endParaRPr lang="zh-TW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橢圓 1">
              <a:extLst>
                <a:ext uri="{FF2B5EF4-FFF2-40B4-BE49-F238E27FC236}">
                  <a16:creationId xmlns:a16="http://schemas.microsoft.com/office/drawing/2014/main" id="{DA716BF4-D494-4769-98C8-C4A98B9FB290}"/>
                </a:ext>
              </a:extLst>
            </p:cNvPr>
            <p:cNvSpPr/>
            <p:nvPr/>
          </p:nvSpPr>
          <p:spPr>
            <a:xfrm>
              <a:off x="5623543" y="4097392"/>
              <a:ext cx="126000" cy="126000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文字方塊 19">
              <a:extLst>
                <a:ext uri="{FF2B5EF4-FFF2-40B4-BE49-F238E27FC236}">
                  <a16:creationId xmlns:a16="http://schemas.microsoft.com/office/drawing/2014/main" id="{FD67878A-F2D6-842A-D613-6EA31CBCC7AE}"/>
                </a:ext>
              </a:extLst>
            </p:cNvPr>
            <p:cNvSpPr txBox="1"/>
            <p:nvPr/>
          </p:nvSpPr>
          <p:spPr>
            <a:xfrm>
              <a:off x="5762133" y="4068059"/>
              <a:ext cx="11878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M female</a:t>
              </a:r>
              <a:endParaRPr lang="zh-TW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8" name="直線接點 134">
              <a:extLst>
                <a:ext uri="{FF2B5EF4-FFF2-40B4-BE49-F238E27FC236}">
                  <a16:creationId xmlns:a16="http://schemas.microsoft.com/office/drawing/2014/main" id="{8A9EFEEF-5507-141B-565C-2D14501C7EB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27200" y="4522939"/>
              <a:ext cx="126000" cy="126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4" name="文字方塊 19">
              <a:extLst>
                <a:ext uri="{FF2B5EF4-FFF2-40B4-BE49-F238E27FC236}">
                  <a16:creationId xmlns:a16="http://schemas.microsoft.com/office/drawing/2014/main" id="{6CD67694-72E7-90C6-8DA7-7CC6FEF413D9}"/>
                </a:ext>
              </a:extLst>
            </p:cNvPr>
            <p:cNvSpPr txBox="1"/>
            <p:nvPr/>
          </p:nvSpPr>
          <p:spPr>
            <a:xfrm>
              <a:off x="5762133" y="4493606"/>
              <a:ext cx="11878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ceased</a:t>
              </a:r>
              <a:endParaRPr lang="zh-TW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5" name="文本框 28">
            <a:extLst>
              <a:ext uri="{FF2B5EF4-FFF2-40B4-BE49-F238E27FC236}">
                <a16:creationId xmlns:a16="http://schemas.microsoft.com/office/drawing/2014/main" id="{D0420CFE-9BFC-49BF-7E5B-58E9718D8FF3}"/>
              </a:ext>
            </a:extLst>
          </p:cNvPr>
          <p:cNvSpPr txBox="1"/>
          <p:nvPr/>
        </p:nvSpPr>
        <p:spPr>
          <a:xfrm>
            <a:off x="234289" y="604492"/>
            <a:ext cx="411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227">
            <a:extLst>
              <a:ext uri="{FF2B5EF4-FFF2-40B4-BE49-F238E27FC236}">
                <a16:creationId xmlns:a16="http://schemas.microsoft.com/office/drawing/2014/main" id="{9AA4AA23-B0DB-17AB-7D43-1E59784F734C}"/>
              </a:ext>
            </a:extLst>
          </p:cNvPr>
          <p:cNvSpPr txBox="1"/>
          <p:nvPr/>
        </p:nvSpPr>
        <p:spPr>
          <a:xfrm>
            <a:off x="440129" y="5042842"/>
            <a:ext cx="6053268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kern="100" dirty="0">
                <a:effectLst/>
                <a:latin typeface="Times New Roman" panose="02020603050405020304" pitchFamily="18" charset="0"/>
                <a:ea typeface="新宋体" panose="02010609030101010101" pitchFamily="49" charset="-122"/>
                <a:cs typeface="Times New Roman" panose="02020603050405020304" pitchFamily="18" charset="0"/>
              </a:rPr>
              <a:t>Supplemental Figure 2</a:t>
            </a:r>
            <a:r>
              <a:rPr lang="en-US" altLang="zh-CN" sz="1200" kern="100" dirty="0">
                <a:latin typeface="Times New Roman" panose="02020603050405020304" pitchFamily="18" charset="0"/>
                <a:ea typeface="新宋体" panose="02010609030101010101" pitchFamily="49" charset="-122"/>
                <a:cs typeface="Times New Roman" panose="02020603050405020304" pitchFamily="18" charset="0"/>
              </a:rPr>
              <a:t>.</a:t>
            </a:r>
            <a:r>
              <a:rPr lang="zh-CN" altLang="en-US" sz="1200" kern="100" dirty="0">
                <a:latin typeface="Times New Roman" panose="02020603050405020304" pitchFamily="18" charset="0"/>
                <a:ea typeface="新宋体" panose="02010609030101010101" pitchFamily="49" charset="-122"/>
                <a:cs typeface="Times New Roman" panose="02020603050405020304" pitchFamily="18" charset="0"/>
              </a:rPr>
              <a:t> </a:t>
            </a:r>
            <a:r>
              <a:rPr lang="zh-CN" altLang="en-US" sz="1200" kern="100" dirty="0">
                <a:effectLst/>
                <a:latin typeface="Times New Roman" panose="02020603050405020304" pitchFamily="18" charset="0"/>
                <a:ea typeface="新宋体" panose="02010609030101010101" pitchFamily="49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edigree charts of (a) Family 20 and (b) Family 21. Circles represent females; squares represent males; hollow symbols represent unaffected individuals or those with intermediate alleles; half-filled symbols represent premutation individuals; solid black symbols represent full mutation individuals; diagonal slashes through symbols indicate deceased individuals; numbers below symbols represent individual identifiers. </a:t>
            </a:r>
            <a:r>
              <a:rPr lang="en-US" altLang="zh-CN" sz="12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OR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normal, </a:t>
            </a:r>
            <a:r>
              <a:rPr lang="en-US" altLang="zh-CN" sz="12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M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ntermediate, </a:t>
            </a:r>
            <a:r>
              <a:rPr lang="en-US" altLang="zh-CN" sz="12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M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remutation, </a:t>
            </a:r>
            <a:r>
              <a:rPr lang="en-US" altLang="zh-CN" sz="12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M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ull mutation</a:t>
            </a:r>
            <a:endParaRPr lang="en-US" altLang="zh-CN" sz="12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10152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3C18194C-F9ED-FB5E-F146-1A14D9BE5490}"/>
              </a:ext>
            </a:extLst>
          </p:cNvPr>
          <p:cNvSpPr txBox="1"/>
          <p:nvPr/>
        </p:nvSpPr>
        <p:spPr>
          <a:xfrm>
            <a:off x="609600" y="6885262"/>
            <a:ext cx="56388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kern="100" dirty="0">
                <a:effectLst/>
                <a:latin typeface="Times New Roman" panose="02020603050405020304" pitchFamily="18" charset="0"/>
                <a:ea typeface="新宋体" panose="02010609030101010101" pitchFamily="49" charset="-122"/>
                <a:cs typeface="Times New Roman" panose="02020603050405020304" pitchFamily="18" charset="0"/>
              </a:rPr>
              <a:t>Supplemental Figure 3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P-PCR/CE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ssay was performed with or without the fourth primer.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sults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 (a) full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utation female (GM07537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, (b)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remutation male (GM06891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and (c)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termediate male (GM20230).​</a:t>
            </a:r>
          </a:p>
        </p:txBody>
      </p:sp>
      <p:pic>
        <p:nvPicPr>
          <p:cNvPr id="4" name="图片 3" descr="图示, 日程表&#10;&#10;AI 生成的内容可能不正确。">
            <a:extLst>
              <a:ext uri="{FF2B5EF4-FFF2-40B4-BE49-F238E27FC236}">
                <a16:creationId xmlns:a16="http://schemas.microsoft.com/office/drawing/2014/main" id="{4217DB79-F034-0E87-401E-63C0BD4D85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1027" y="332349"/>
            <a:ext cx="4629912" cy="64404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655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134</TotalTime>
  <Words>180</Words>
  <Application>Microsoft Office PowerPoint</Application>
  <PresentationFormat>A4 纸张(210x297 毫米)</PresentationFormat>
  <Paragraphs>15</Paragraphs>
  <Slides>3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Times New Roman</vt:lpstr>
      <vt:lpstr>Office 2013 - 2022 Theme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Z L</dc:creator>
  <cp:lastModifiedBy>xy S</cp:lastModifiedBy>
  <cp:revision>52</cp:revision>
  <dcterms:created xsi:type="dcterms:W3CDTF">2025-03-31T08:37:17Z</dcterms:created>
  <dcterms:modified xsi:type="dcterms:W3CDTF">2025-09-01T00:42:24Z</dcterms:modified>
</cp:coreProperties>
</file>